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81" d="100"/>
          <a:sy n="81" d="100"/>
        </p:scale>
        <p:origin x="14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46E4C7-578F-4D79-AE17-0BFEA092465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8B3C68E-25FC-4B5A-AD59-2FD737068C7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F4E9E7-3FE2-4BF0-817D-174DCFF9FA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E4F27-6715-4A66-A303-70764F55AEC6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5F152F-9A4C-41FF-B3A2-86BC80095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B28818-DA09-4C05-B174-AF46F0DEC5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418FD-107C-4225-90C2-380AF92CF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0487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4B3714-F905-41C7-B638-B4598381DD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5FA6158-F048-4319-93E5-C8688CC7A8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5E779D-A2A2-45BE-8729-8F72CF6068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E4F27-6715-4A66-A303-70764F55AEC6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D983E2-8DED-4E4A-B669-8158A6ED40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55C943-7678-4ED4-95DF-1437187E8F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418FD-107C-4225-90C2-380AF92CF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3585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7F9005-CF7B-4B78-9800-43979E6405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D0FA8D-5E37-4754-B62C-42407740AA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0CC27E-F0FD-45F8-8026-D9151FA124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E4F27-6715-4A66-A303-70764F55AEC6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DE4777-BC2F-4D76-BA8F-B665601D7F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8C070B-D552-4A5E-9D2A-E1A73E5726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418FD-107C-4225-90C2-380AF92CF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84380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16F5E8-EEB5-45B1-9316-6BDD120344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52A1CB-46CE-4715-BF87-6FCDF8A87E7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AD737C-9F0C-4C14-BE6F-0F39FCE88F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E4F27-6715-4A66-A303-70764F55AEC6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550365-5574-4C5E-B8D5-A00CCA0C30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5C4933-9B0F-4DE9-965A-8CA955FEE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418FD-107C-4225-90C2-380AF92CF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3043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6581E8-C09B-4DD8-B458-8F30257DBE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8D8904-AA33-4DD3-8359-34F22A5B1B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7C2B8D-889A-42E7-B59B-1C4B38BE97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E4F27-6715-4A66-A303-70764F55AEC6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0A2730-A10C-49ED-9F5F-121F0F3FCD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8CCBE1-8C59-4F8A-B8BB-DB51B4BCA0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418FD-107C-4225-90C2-380AF92CF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00786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D60671-3472-4FDF-AED2-070D3E8900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0D0E72-1C12-4D1A-9E7F-CC94C1AE42A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FF816E4-6E38-411D-826D-18C737E434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DFD85E-A9C4-4950-ABCD-77F9DFA5F5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E4F27-6715-4A66-A303-70764F55AEC6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A42067-187D-4579-A386-1E0DA63DC7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951478-0DE0-4F39-A55A-2E8F16D0BC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418FD-107C-4225-90C2-380AF92CF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05841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642B73-FC8D-42D9-B502-67B967B22B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2C3213-02EB-4D1F-83B2-18150138D0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A4C4924-45D5-415C-A757-8475AE58B4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95A559D-0634-47F4-BE67-2BC170A8ED0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0153F6-1B5C-4F8F-A7BC-096AB835271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44225C9-AFDB-41E4-A55F-2E607CC116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E4F27-6715-4A66-A303-70764F55AEC6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8926C7D-29B2-4895-9B36-8BF24A1608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FE6DBC0-2C55-4009-846C-7151A62549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418FD-107C-4225-90C2-380AF92CF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6921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40E6AB-C4CB-4E7A-9398-F27E64B540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1A6D2A3-E802-4979-B14C-F1BFF96C82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E4F27-6715-4A66-A303-70764F55AEC6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3DA0894-109F-489A-B509-430E635B8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A9E3C8B-AFCD-4928-A362-175544F744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418FD-107C-4225-90C2-380AF92CF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8099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242FF7D-203E-4B73-B74E-861F52B9ED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E4F27-6715-4A66-A303-70764F55AEC6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6AE4888-2D8D-43BE-ACDB-D954E4AB26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44142DA-B489-4E6C-982C-E6A5DE1262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418FD-107C-4225-90C2-380AF92CF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91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B219DA-A57D-4F1D-8238-C95B558E55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B88A76-FDA2-4127-96AA-09A1E36581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926898-1495-4D26-81BE-3B554C6177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E67E00-4D4B-404C-B9B9-B9C6C479B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E4F27-6715-4A66-A303-70764F55AEC6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DCF220-B83F-47BC-BC98-148B69D396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75D394-82D6-4C54-8F43-E922EB3247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418FD-107C-4225-90C2-380AF92CF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05149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BB3B0C-8B2C-4365-ABCC-C7114B0262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11D9C76-18B9-4073-B209-901AF918D45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8BA4A7B-ABC8-44D5-AED8-B29CF671FC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263D6B-D6EC-4DB9-9E15-7C91F76949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E4F27-6715-4A66-A303-70764F55AEC6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2BCFEB-64A8-4032-8B29-74C7644097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7E52C2-5D91-4164-B3F4-907D98F9EF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F418FD-107C-4225-90C2-380AF92CF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67779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14D25BC-16D3-4057-84AE-FB50CEC13D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C50E51-ACE5-47FC-8E05-F36ED33AB1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519DBB-66F7-4A5A-8BF5-83A2FEEC028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0E4F27-6715-4A66-A303-70764F55AEC6}" type="datetimeFigureOut">
              <a:rPr lang="en-US" smtClean="0"/>
              <a:t>8/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2E0AB5-90C7-40AB-A148-CEC09399A1E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575963-742E-4C82-B60E-72ECAF64B97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F418FD-107C-4225-90C2-380AF92CF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7596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C239C36-A4F4-47A9-B903-46D737C575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9326304" y="61189"/>
            <a:ext cx="2844800" cy="365125"/>
          </a:xfrm>
        </p:spPr>
        <p:txBody>
          <a:bodyPr/>
          <a:lstStyle/>
          <a:p>
            <a:fld id="{843A97E6-F245-B645-9B91-4B3AB6E62A0C}" type="slidenum">
              <a:rPr lang="en-US" smtClean="0"/>
              <a:pPr/>
              <a:t>1</a:t>
            </a:fld>
            <a:endParaRPr lang="en-US" dirty="0"/>
          </a:p>
        </p:txBody>
      </p:sp>
      <p:pic>
        <p:nvPicPr>
          <p:cNvPr id="5" name="Picture 4" descr="A group of palm trees&#10;&#10;Description generated with very high confidence">
            <a:extLst>
              <a:ext uri="{FF2B5EF4-FFF2-40B4-BE49-F238E27FC236}">
                <a16:creationId xmlns:a16="http://schemas.microsoft.com/office/drawing/2014/main" id="{21743E15-3972-406D-9D32-D39B85085F8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030466">
            <a:off x="923880" y="3888017"/>
            <a:ext cx="3848321" cy="2886241"/>
          </a:xfrm>
          <a:prstGeom prst="rect">
            <a:avLst/>
          </a:prstGeom>
          <a:ln>
            <a:solidFill>
              <a:srgbClr val="92D050"/>
            </a:solidFill>
          </a:ln>
          <a:scene3d>
            <a:camera prst="orthographicFront">
              <a:rot lat="18060000" lon="3180000" rev="18120000"/>
            </a:camera>
            <a:lightRig rig="threePt" dir="t">
              <a:rot lat="0" lon="0" rev="11400000"/>
            </a:lightRig>
          </a:scene3d>
        </p:spPr>
      </p:pic>
      <p:pic>
        <p:nvPicPr>
          <p:cNvPr id="6" name="Picture 5" descr="A group of palm trees&#10;&#10;Description generated with very high confidence">
            <a:extLst>
              <a:ext uri="{FF2B5EF4-FFF2-40B4-BE49-F238E27FC236}">
                <a16:creationId xmlns:a16="http://schemas.microsoft.com/office/drawing/2014/main" id="{C4CDC937-4F09-4563-AABE-F7FC21F600B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030466">
            <a:off x="1537673" y="3939358"/>
            <a:ext cx="2877168" cy="2157876"/>
          </a:xfrm>
          <a:prstGeom prst="rect">
            <a:avLst/>
          </a:prstGeom>
          <a:ln>
            <a:solidFill>
              <a:srgbClr val="92D050"/>
            </a:solidFill>
          </a:ln>
          <a:scene3d>
            <a:camera prst="orthographicFront">
              <a:rot lat="18060000" lon="3180000" rev="18120000"/>
            </a:camera>
            <a:lightRig rig="threePt" dir="t">
              <a:rot lat="0" lon="0" rev="11400000"/>
            </a:lightRig>
          </a:scene3d>
        </p:spPr>
      </p:pic>
      <p:pic>
        <p:nvPicPr>
          <p:cNvPr id="7" name="Picture 6" descr="A group of palm trees&#10;&#10;Description generated with very high confidence">
            <a:extLst>
              <a:ext uri="{FF2B5EF4-FFF2-40B4-BE49-F238E27FC236}">
                <a16:creationId xmlns:a16="http://schemas.microsoft.com/office/drawing/2014/main" id="{2E0A0534-0433-499B-AE40-EA5508C2263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030466">
            <a:off x="1958337" y="3845195"/>
            <a:ext cx="2307531" cy="1730648"/>
          </a:xfrm>
          <a:prstGeom prst="rect">
            <a:avLst/>
          </a:prstGeom>
          <a:ln>
            <a:solidFill>
              <a:srgbClr val="92D050"/>
            </a:solidFill>
          </a:ln>
          <a:scene3d>
            <a:camera prst="orthographicFront">
              <a:rot lat="18060000" lon="3180000" rev="18120000"/>
            </a:camera>
            <a:lightRig rig="threePt" dir="t">
              <a:rot lat="0" lon="0" rev="11400000"/>
            </a:lightRig>
          </a:scene3d>
        </p:spPr>
      </p:pic>
      <p:pic>
        <p:nvPicPr>
          <p:cNvPr id="8" name="Picture 7" descr="A group of palm trees&#10;&#10;Description generated with very high confidence">
            <a:extLst>
              <a:ext uri="{FF2B5EF4-FFF2-40B4-BE49-F238E27FC236}">
                <a16:creationId xmlns:a16="http://schemas.microsoft.com/office/drawing/2014/main" id="{84100158-70F8-4EBD-9A94-D7FC829CED9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030466">
            <a:off x="2135960" y="3827590"/>
            <a:ext cx="1727317" cy="1295488"/>
          </a:xfrm>
          <a:prstGeom prst="rect">
            <a:avLst/>
          </a:prstGeom>
          <a:ln>
            <a:solidFill>
              <a:srgbClr val="92D050"/>
            </a:solidFill>
          </a:ln>
          <a:scene3d>
            <a:camera prst="orthographicFront">
              <a:rot lat="18060000" lon="3180000" rev="18120000"/>
            </a:camera>
            <a:lightRig rig="threePt" dir="t">
              <a:rot lat="0" lon="0" rev="11400000"/>
            </a:lightRig>
          </a:scene3d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588738DD-A646-4894-8540-8BA8CDF3E951}"/>
              </a:ext>
            </a:extLst>
          </p:cNvPr>
          <p:cNvSpPr/>
          <p:nvPr/>
        </p:nvSpPr>
        <p:spPr>
          <a:xfrm rot="21205483">
            <a:off x="5253432" y="4582982"/>
            <a:ext cx="2222665" cy="1302828"/>
          </a:xfrm>
          <a:prstGeom prst="rect">
            <a:avLst/>
          </a:prstGeom>
          <a:noFill/>
          <a:ln w="57150"/>
          <a:scene3d>
            <a:camera prst="isometricOffAxis2Top"/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35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5A5A8814-D771-44C4-A8FB-AE1048286ACA}"/>
              </a:ext>
            </a:extLst>
          </p:cNvPr>
          <p:cNvCxnSpPr>
            <a:cxnSpLocks/>
          </p:cNvCxnSpPr>
          <p:nvPr/>
        </p:nvCxnSpPr>
        <p:spPr>
          <a:xfrm flipV="1">
            <a:off x="2717997" y="5383072"/>
            <a:ext cx="9063" cy="178802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tailEnd type="triangle"/>
          </a:ln>
          <a:scene3d>
            <a:camera prst="orthographicFront">
              <a:rot lat="20999999" lon="20999996" rev="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1C88D28A-005B-4F8F-8CA5-5262AA214AE8}"/>
              </a:ext>
            </a:extLst>
          </p:cNvPr>
          <p:cNvCxnSpPr>
            <a:cxnSpLocks/>
          </p:cNvCxnSpPr>
          <p:nvPr/>
        </p:nvCxnSpPr>
        <p:spPr>
          <a:xfrm flipV="1">
            <a:off x="2727060" y="5018295"/>
            <a:ext cx="9063" cy="178802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tailEnd type="triangle"/>
          </a:ln>
          <a:scene3d>
            <a:camera prst="orthographicFront">
              <a:rot lat="20999999" lon="20999996" rev="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C075E0F8-8CC1-4EC8-ADD0-059E33B517BB}"/>
              </a:ext>
            </a:extLst>
          </p:cNvPr>
          <p:cNvCxnSpPr>
            <a:cxnSpLocks/>
          </p:cNvCxnSpPr>
          <p:nvPr/>
        </p:nvCxnSpPr>
        <p:spPr>
          <a:xfrm flipV="1">
            <a:off x="2737882" y="4692226"/>
            <a:ext cx="9063" cy="178802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tailEnd type="triangle"/>
          </a:ln>
          <a:scene3d>
            <a:camera prst="orthographicFront">
              <a:rot lat="20999999" lon="20999996" rev="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E5589882-BA79-432E-875D-46D836CD2542}"/>
              </a:ext>
            </a:extLst>
          </p:cNvPr>
          <p:cNvCxnSpPr>
            <a:cxnSpLocks/>
          </p:cNvCxnSpPr>
          <p:nvPr/>
        </p:nvCxnSpPr>
        <p:spPr>
          <a:xfrm>
            <a:off x="6154617" y="4698973"/>
            <a:ext cx="0" cy="192805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tailEnd type="triangle"/>
          </a:ln>
          <a:scene3d>
            <a:camera prst="orthographicFront">
              <a:rot lat="20999999" lon="20999996" rev="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Rectangle 13">
            <a:extLst>
              <a:ext uri="{FF2B5EF4-FFF2-40B4-BE49-F238E27FC236}">
                <a16:creationId xmlns:a16="http://schemas.microsoft.com/office/drawing/2014/main" id="{119BE746-694B-4DF2-A9A0-31BC49C799FA}"/>
              </a:ext>
            </a:extLst>
          </p:cNvPr>
          <p:cNvSpPr/>
          <p:nvPr/>
        </p:nvSpPr>
        <p:spPr>
          <a:xfrm rot="21205483">
            <a:off x="5363437" y="4193968"/>
            <a:ext cx="1857597" cy="1302828"/>
          </a:xfrm>
          <a:prstGeom prst="rect">
            <a:avLst/>
          </a:prstGeom>
          <a:solidFill>
            <a:schemeClr val="bg1"/>
          </a:solidFill>
          <a:ln w="57150"/>
          <a:scene3d>
            <a:camera prst="isometricOffAxis2Top"/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35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C8B81F68-D77C-4F79-9F40-7305A0CDB414}"/>
              </a:ext>
            </a:extLst>
          </p:cNvPr>
          <p:cNvSpPr/>
          <p:nvPr/>
        </p:nvSpPr>
        <p:spPr>
          <a:xfrm rot="21205483">
            <a:off x="5513394" y="3817423"/>
            <a:ext cx="1551582" cy="1302828"/>
          </a:xfrm>
          <a:prstGeom prst="rect">
            <a:avLst/>
          </a:prstGeom>
          <a:solidFill>
            <a:schemeClr val="bg1"/>
          </a:solidFill>
          <a:ln w="57150"/>
          <a:scene3d>
            <a:camera prst="isometricOffAxis2Top"/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35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B65AC1A8-2334-4BA5-B131-C6EBA855B424}"/>
              </a:ext>
            </a:extLst>
          </p:cNvPr>
          <p:cNvCxnSpPr>
            <a:cxnSpLocks/>
          </p:cNvCxnSpPr>
          <p:nvPr/>
        </p:nvCxnSpPr>
        <p:spPr>
          <a:xfrm>
            <a:off x="6619437" y="4824080"/>
            <a:ext cx="0" cy="201575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tailEnd type="triangle"/>
          </a:ln>
          <a:scene3d>
            <a:camera prst="orthographicFront">
              <a:rot lat="20999999" lon="20999996" rev="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F8A2DE3B-2249-4829-B740-98DB334F3523}"/>
              </a:ext>
            </a:extLst>
          </p:cNvPr>
          <p:cNvCxnSpPr>
            <a:cxnSpLocks/>
          </p:cNvCxnSpPr>
          <p:nvPr/>
        </p:nvCxnSpPr>
        <p:spPr>
          <a:xfrm>
            <a:off x="6581337" y="5188102"/>
            <a:ext cx="0" cy="181135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tailEnd type="triangle"/>
          </a:ln>
          <a:scene3d>
            <a:camera prst="orthographicFront">
              <a:rot lat="20999999" lon="20999996" rev="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Rectangle 17">
            <a:extLst>
              <a:ext uri="{FF2B5EF4-FFF2-40B4-BE49-F238E27FC236}">
                <a16:creationId xmlns:a16="http://schemas.microsoft.com/office/drawing/2014/main" id="{D9DF240F-8618-4EE3-81CB-AA09A098D98E}"/>
              </a:ext>
            </a:extLst>
          </p:cNvPr>
          <p:cNvSpPr/>
          <p:nvPr/>
        </p:nvSpPr>
        <p:spPr>
          <a:xfrm>
            <a:off x="7800174" y="3938008"/>
            <a:ext cx="174195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solidFill>
                  <a:prstClr val="black"/>
                </a:solidFill>
                <a:latin typeface="Times" panose="02020603050405020304" pitchFamily="18" charset="0"/>
                <a:cs typeface="Times" panose="02020603050405020304" pitchFamily="18" charset="0"/>
              </a:rPr>
              <a:t>Object classifier</a:t>
            </a:r>
            <a:endParaRPr lang="en-US" sz="1400" dirty="0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959F9215-41F9-41C9-9F61-E933DC3B7E42}"/>
              </a:ext>
            </a:extLst>
          </p:cNvPr>
          <p:cNvSpPr/>
          <p:nvPr/>
        </p:nvSpPr>
        <p:spPr>
          <a:xfrm>
            <a:off x="7514346" y="4147321"/>
            <a:ext cx="196249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00" dirty="0">
                <a:solidFill>
                  <a:prstClr val="black"/>
                </a:solidFill>
                <a:latin typeface="Times" panose="02020603050405020304" pitchFamily="18" charset="0"/>
                <a:cs typeface="Times" panose="02020603050405020304" pitchFamily="18" charset="0"/>
              </a:rPr>
              <a:t>Bounding box regressor</a:t>
            </a:r>
            <a:endParaRPr lang="en-US" sz="1400" dirty="0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4F8F6639-BE11-473E-93BF-F59B6F1FDC1E}"/>
              </a:ext>
            </a:extLst>
          </p:cNvPr>
          <p:cNvSpPr/>
          <p:nvPr/>
        </p:nvSpPr>
        <p:spPr>
          <a:xfrm>
            <a:off x="7809700" y="4374312"/>
            <a:ext cx="139458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solidFill>
                  <a:prstClr val="black"/>
                </a:solidFill>
                <a:latin typeface="Times" panose="02020603050405020304" pitchFamily="18" charset="0"/>
                <a:cs typeface="Times" panose="02020603050405020304" pitchFamily="18" charset="0"/>
              </a:rPr>
              <a:t>Object classifier</a:t>
            </a:r>
            <a:endParaRPr lang="en-US" sz="1400" dirty="0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26549718-BE02-4091-B4EC-D0DFDD56930A}"/>
              </a:ext>
            </a:extLst>
          </p:cNvPr>
          <p:cNvSpPr/>
          <p:nvPr/>
        </p:nvSpPr>
        <p:spPr>
          <a:xfrm>
            <a:off x="7514346" y="4583625"/>
            <a:ext cx="196249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00" dirty="0">
                <a:solidFill>
                  <a:prstClr val="black"/>
                </a:solidFill>
                <a:latin typeface="Times" panose="02020603050405020304" pitchFamily="18" charset="0"/>
                <a:cs typeface="Times" panose="02020603050405020304" pitchFamily="18" charset="0"/>
              </a:rPr>
              <a:t>Bounding box regressor</a:t>
            </a:r>
            <a:endParaRPr lang="en-US" sz="1400" dirty="0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BF63C552-45A3-4E3C-8601-923B3C304EBC}"/>
              </a:ext>
            </a:extLst>
          </p:cNvPr>
          <p:cNvSpPr/>
          <p:nvPr/>
        </p:nvSpPr>
        <p:spPr>
          <a:xfrm>
            <a:off x="7772732" y="4810616"/>
            <a:ext cx="139458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solidFill>
                  <a:prstClr val="black"/>
                </a:solidFill>
                <a:latin typeface="Times" panose="02020603050405020304" pitchFamily="18" charset="0"/>
                <a:cs typeface="Times" panose="02020603050405020304" pitchFamily="18" charset="0"/>
              </a:rPr>
              <a:t>Object classifier</a:t>
            </a:r>
            <a:endParaRPr lang="en-US" sz="1400" dirty="0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B8E3533F-195D-42BE-9BBF-F511B7AE6DBE}"/>
              </a:ext>
            </a:extLst>
          </p:cNvPr>
          <p:cNvSpPr/>
          <p:nvPr/>
        </p:nvSpPr>
        <p:spPr>
          <a:xfrm>
            <a:off x="7515478" y="5019929"/>
            <a:ext cx="196249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sz="1400" dirty="0">
                <a:solidFill>
                  <a:prstClr val="black"/>
                </a:solidFill>
                <a:latin typeface="Times" panose="02020603050405020304" pitchFamily="18" charset="0"/>
                <a:cs typeface="Times" panose="02020603050405020304" pitchFamily="18" charset="0"/>
              </a:rPr>
              <a:t>Bounding box regressor</a:t>
            </a:r>
            <a:endParaRPr lang="en-US" sz="1400" dirty="0"/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A3F29825-5853-40F7-ACE8-4D05641BBF56}"/>
              </a:ext>
            </a:extLst>
          </p:cNvPr>
          <p:cNvCxnSpPr>
            <a:cxnSpLocks/>
          </p:cNvCxnSpPr>
          <p:nvPr/>
        </p:nvCxnSpPr>
        <p:spPr>
          <a:xfrm flipV="1">
            <a:off x="7119226" y="4382731"/>
            <a:ext cx="2657242" cy="70867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tailEnd type="triangle"/>
          </a:ln>
          <a:scene3d>
            <a:camera prst="orthographicFront">
              <a:rot lat="20999999" lon="20999996" rev="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D10F2FCC-EC4A-45BB-80DA-218E3249A7B3}"/>
              </a:ext>
            </a:extLst>
          </p:cNvPr>
          <p:cNvCxnSpPr>
            <a:cxnSpLocks/>
          </p:cNvCxnSpPr>
          <p:nvPr/>
        </p:nvCxnSpPr>
        <p:spPr>
          <a:xfrm flipV="1">
            <a:off x="7214458" y="4819035"/>
            <a:ext cx="2569630" cy="51945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tailEnd type="triangle"/>
          </a:ln>
          <a:scene3d>
            <a:camera prst="orthographicFront">
              <a:rot lat="20999999" lon="20999996" rev="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86B7CF13-CF6A-4372-9C38-D000DD03FA20}"/>
              </a:ext>
            </a:extLst>
          </p:cNvPr>
          <p:cNvCxnSpPr>
            <a:cxnSpLocks/>
          </p:cNvCxnSpPr>
          <p:nvPr/>
        </p:nvCxnSpPr>
        <p:spPr>
          <a:xfrm flipV="1">
            <a:off x="7373722" y="5258680"/>
            <a:ext cx="2402746" cy="46166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tailEnd type="triangle"/>
          </a:ln>
          <a:scene3d>
            <a:camera prst="orthographicFront">
              <a:rot lat="20999999" lon="20999996" rev="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4D4DDD73-4071-45ED-B082-5132DF947216}"/>
              </a:ext>
            </a:extLst>
          </p:cNvPr>
          <p:cNvCxnSpPr>
            <a:cxnSpLocks/>
          </p:cNvCxnSpPr>
          <p:nvPr/>
        </p:nvCxnSpPr>
        <p:spPr>
          <a:xfrm flipV="1">
            <a:off x="4067079" y="5166613"/>
            <a:ext cx="2543036" cy="73956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tailEnd type="triangle"/>
          </a:ln>
          <a:scene3d>
            <a:camera prst="orthographicFront">
              <a:rot lat="20999999" lon="20999996" rev="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EA243EC3-610A-4B15-9121-49AB6A2090EA}"/>
              </a:ext>
            </a:extLst>
          </p:cNvPr>
          <p:cNvCxnSpPr>
            <a:cxnSpLocks/>
          </p:cNvCxnSpPr>
          <p:nvPr/>
        </p:nvCxnSpPr>
        <p:spPr>
          <a:xfrm>
            <a:off x="6638471" y="4394779"/>
            <a:ext cx="0" cy="238907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tailEnd type="triangle"/>
          </a:ln>
          <a:scene3d>
            <a:camera prst="orthographicFront">
              <a:rot lat="20999999" lon="20999996" rev="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0DA05655-8582-4321-B942-02E0893AA0D0}"/>
              </a:ext>
            </a:extLst>
          </p:cNvPr>
          <p:cNvCxnSpPr>
            <a:cxnSpLocks/>
          </p:cNvCxnSpPr>
          <p:nvPr/>
        </p:nvCxnSpPr>
        <p:spPr>
          <a:xfrm flipV="1">
            <a:off x="3992283" y="4785822"/>
            <a:ext cx="2656502" cy="73856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tailEnd type="triangle"/>
          </a:ln>
          <a:scene3d>
            <a:camera prst="orthographicFront">
              <a:rot lat="20999999" lon="20999996" rev="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76B4CADF-EEF2-4BB7-87D0-71CDE0E669B0}"/>
              </a:ext>
            </a:extLst>
          </p:cNvPr>
          <p:cNvCxnSpPr>
            <a:cxnSpLocks/>
          </p:cNvCxnSpPr>
          <p:nvPr/>
        </p:nvCxnSpPr>
        <p:spPr>
          <a:xfrm flipV="1">
            <a:off x="3861329" y="4335214"/>
            <a:ext cx="2818751" cy="65456"/>
          </a:xfrm>
          <a:prstGeom prst="straightConnector1">
            <a:avLst/>
          </a:prstGeom>
          <a:ln>
            <a:solidFill>
              <a:schemeClr val="accent6">
                <a:lumMod val="50000"/>
              </a:schemeClr>
            </a:solidFill>
            <a:tailEnd type="triangle"/>
          </a:ln>
          <a:scene3d>
            <a:camera prst="orthographicFront">
              <a:rot lat="20999999" lon="20999996" rev="0"/>
            </a:camera>
            <a:lightRig rig="threePt" dir="t"/>
          </a:scene3d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Rectangle 30">
            <a:extLst>
              <a:ext uri="{FF2B5EF4-FFF2-40B4-BE49-F238E27FC236}">
                <a16:creationId xmlns:a16="http://schemas.microsoft.com/office/drawing/2014/main" id="{9D5E76E8-3E2C-4DE9-B0D6-19802B3864C4}"/>
              </a:ext>
            </a:extLst>
          </p:cNvPr>
          <p:cNvSpPr/>
          <p:nvPr/>
        </p:nvSpPr>
        <p:spPr>
          <a:xfrm>
            <a:off x="10215614" y="4441284"/>
            <a:ext cx="110128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solidFill>
                  <a:prstClr val="black"/>
                </a:solidFill>
                <a:latin typeface="Times" panose="02020603050405020304" pitchFamily="18" charset="0"/>
                <a:cs typeface="Times" panose="02020603050405020304" pitchFamily="18" charset="0"/>
              </a:rPr>
              <a:t>non-maximum</a:t>
            </a:r>
          </a:p>
          <a:p>
            <a:pPr algn="ctr"/>
            <a:r>
              <a:rPr lang="en-US" sz="1400" dirty="0">
                <a:solidFill>
                  <a:prstClr val="black"/>
                </a:solidFill>
                <a:latin typeface="Times" panose="02020603050405020304" pitchFamily="18" charset="0"/>
                <a:cs typeface="Times" panose="02020603050405020304" pitchFamily="18" charset="0"/>
              </a:rPr>
              <a:t>suppression</a:t>
            </a:r>
            <a:endParaRPr lang="en-US" sz="1400" dirty="0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55C72E0A-79BD-49F1-A787-7425ADE9A437}"/>
              </a:ext>
            </a:extLst>
          </p:cNvPr>
          <p:cNvSpPr/>
          <p:nvPr/>
        </p:nvSpPr>
        <p:spPr>
          <a:xfrm>
            <a:off x="11273024" y="4462004"/>
            <a:ext cx="110128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solidFill>
                  <a:prstClr val="black"/>
                </a:solidFill>
                <a:latin typeface="Times" panose="02020603050405020304" pitchFamily="18" charset="0"/>
                <a:cs typeface="Times" panose="02020603050405020304" pitchFamily="18" charset="0"/>
              </a:rPr>
              <a:t>Tassel</a:t>
            </a:r>
          </a:p>
          <a:p>
            <a:pPr algn="ctr"/>
            <a:r>
              <a:rPr lang="en-US" sz="1400" dirty="0">
                <a:solidFill>
                  <a:prstClr val="black"/>
                </a:solidFill>
                <a:latin typeface="Times" panose="02020603050405020304" pitchFamily="18" charset="0"/>
                <a:cs typeface="Times" panose="02020603050405020304" pitchFamily="18" charset="0"/>
              </a:rPr>
              <a:t> bounding boxes</a:t>
            </a:r>
            <a:endParaRPr lang="en-US" sz="1400" dirty="0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2963C510-1978-4D1A-A351-DB0EBBE08623}"/>
              </a:ext>
            </a:extLst>
          </p:cNvPr>
          <p:cNvSpPr/>
          <p:nvPr/>
        </p:nvSpPr>
        <p:spPr>
          <a:xfrm>
            <a:off x="9756864" y="4407357"/>
            <a:ext cx="415407" cy="907241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0C1E93CE-B90A-4307-9607-4AE4A4BD83BF}"/>
              </a:ext>
            </a:extLst>
          </p:cNvPr>
          <p:cNvCxnSpPr>
            <a:cxnSpLocks/>
            <a:stCxn id="33" idx="1"/>
          </p:cNvCxnSpPr>
          <p:nvPr/>
        </p:nvCxnSpPr>
        <p:spPr>
          <a:xfrm flipV="1">
            <a:off x="9756864" y="4859678"/>
            <a:ext cx="609911" cy="130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92B8CAE5-34D2-4DF8-8328-9F75F68FBB55}"/>
              </a:ext>
            </a:extLst>
          </p:cNvPr>
          <p:cNvCxnSpPr>
            <a:cxnSpLocks/>
          </p:cNvCxnSpPr>
          <p:nvPr/>
        </p:nvCxnSpPr>
        <p:spPr>
          <a:xfrm>
            <a:off x="11164338" y="4844036"/>
            <a:ext cx="324586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Title 1">
            <a:extLst>
              <a:ext uri="{FF2B5EF4-FFF2-40B4-BE49-F238E27FC236}">
                <a16:creationId xmlns:a16="http://schemas.microsoft.com/office/drawing/2014/main" id="{07591D06-1DE1-40C0-966A-D2356AA1F7DD}"/>
              </a:ext>
            </a:extLst>
          </p:cNvPr>
          <p:cNvSpPr txBox="1">
            <a:spLocks/>
          </p:cNvSpPr>
          <p:nvPr/>
        </p:nvSpPr>
        <p:spPr>
          <a:xfrm>
            <a:off x="5027474" y="-21093"/>
            <a:ext cx="3203283" cy="605899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2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Computer Vision</a:t>
            </a: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A644EB19-8247-47AA-A62B-872CCB38CC3C}"/>
              </a:ext>
            </a:extLst>
          </p:cNvPr>
          <p:cNvSpPr/>
          <p:nvPr/>
        </p:nvSpPr>
        <p:spPr>
          <a:xfrm>
            <a:off x="-63501" y="4013399"/>
            <a:ext cx="14991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prstClr val="black"/>
                </a:solidFill>
                <a:latin typeface="Times" panose="02020603050405020304" pitchFamily="18" charset="0"/>
                <a:cs typeface="Times" panose="02020603050405020304" pitchFamily="18" charset="0"/>
              </a:rPr>
              <a:t>Strong feature</a:t>
            </a:r>
            <a:endParaRPr lang="en-US" dirty="0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403B6E52-6E8E-4160-A55A-C319019ACF9B}"/>
              </a:ext>
            </a:extLst>
          </p:cNvPr>
          <p:cNvSpPr/>
          <p:nvPr/>
        </p:nvSpPr>
        <p:spPr>
          <a:xfrm>
            <a:off x="-37329" y="5314598"/>
            <a:ext cx="106952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prstClr val="black"/>
                </a:solidFill>
                <a:latin typeface="Times" panose="02020603050405020304" pitchFamily="18" charset="0"/>
                <a:cs typeface="Times" panose="02020603050405020304" pitchFamily="18" charset="0"/>
              </a:rPr>
              <a:t>High-Res</a:t>
            </a:r>
            <a:endParaRPr lang="en-US" dirty="0"/>
          </a:p>
        </p:txBody>
      </p: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D34FF6F6-8C75-41BD-A8CD-2283921D0E30}"/>
              </a:ext>
            </a:extLst>
          </p:cNvPr>
          <p:cNvCxnSpPr/>
          <p:nvPr/>
        </p:nvCxnSpPr>
        <p:spPr>
          <a:xfrm flipV="1">
            <a:off x="525684" y="4367942"/>
            <a:ext cx="12499" cy="946656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0" name="Rectangle 39">
            <a:extLst>
              <a:ext uri="{FF2B5EF4-FFF2-40B4-BE49-F238E27FC236}">
                <a16:creationId xmlns:a16="http://schemas.microsoft.com/office/drawing/2014/main" id="{251959F2-1845-41D6-AF06-8DB922DA619D}"/>
              </a:ext>
            </a:extLst>
          </p:cNvPr>
          <p:cNvSpPr/>
          <p:nvPr/>
        </p:nvSpPr>
        <p:spPr>
          <a:xfrm>
            <a:off x="1620391" y="4681538"/>
            <a:ext cx="7489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prstClr val="black"/>
                </a:solidFill>
                <a:latin typeface="Times" panose="02020603050405020304" pitchFamily="18" charset="0"/>
                <a:cs typeface="Times" panose="02020603050405020304" pitchFamily="18" charset="0"/>
              </a:rPr>
              <a:t>conv4</a:t>
            </a:r>
            <a:endParaRPr lang="en-US" dirty="0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B76FC3D2-5DE3-4DBC-9F99-D9F7B09B10AE}"/>
              </a:ext>
            </a:extLst>
          </p:cNvPr>
          <p:cNvSpPr/>
          <p:nvPr/>
        </p:nvSpPr>
        <p:spPr>
          <a:xfrm>
            <a:off x="1618195" y="4366352"/>
            <a:ext cx="7489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prstClr val="black"/>
                </a:solidFill>
                <a:latin typeface="Times" panose="02020603050405020304" pitchFamily="18" charset="0"/>
                <a:cs typeface="Times" panose="02020603050405020304" pitchFamily="18" charset="0"/>
              </a:rPr>
              <a:t>conv5</a:t>
            </a:r>
            <a:endParaRPr lang="en-US" dirty="0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AB4F77F6-52D7-4B04-846C-5B1C6B47496A}"/>
              </a:ext>
            </a:extLst>
          </p:cNvPr>
          <p:cNvSpPr/>
          <p:nvPr/>
        </p:nvSpPr>
        <p:spPr>
          <a:xfrm>
            <a:off x="1622587" y="5025655"/>
            <a:ext cx="7489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prstClr val="black"/>
                </a:solidFill>
                <a:latin typeface="Times" panose="02020603050405020304" pitchFamily="18" charset="0"/>
                <a:cs typeface="Times" panose="02020603050405020304" pitchFamily="18" charset="0"/>
              </a:rPr>
              <a:t>conv3</a:t>
            </a:r>
            <a:endParaRPr lang="en-US" dirty="0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74C6F33F-DDB7-487F-8869-50B54A64CBE7}"/>
              </a:ext>
            </a:extLst>
          </p:cNvPr>
          <p:cNvSpPr/>
          <p:nvPr/>
        </p:nvSpPr>
        <p:spPr>
          <a:xfrm>
            <a:off x="753811" y="4698973"/>
            <a:ext cx="8643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>
                <a:solidFill>
                  <a:prstClr val="black"/>
                </a:solidFill>
                <a:latin typeface="Times" panose="02020603050405020304" pitchFamily="18" charset="0"/>
                <a:cs typeface="Times" panose="02020603050405020304" pitchFamily="18" charset="0"/>
              </a:rPr>
              <a:t>ResNe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7289972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>
                      <p:stCondLst>
                        <p:cond delay="indefinite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fill="hold">
                      <p:stCondLst>
                        <p:cond delay="indefinite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1" fill="hold">
                      <p:stCondLst>
                        <p:cond delay="indefinite"/>
                      </p:stCondLst>
                      <p:childTnLst>
                        <p:par>
                          <p:cTn id="42" fill="hold">
                            <p:stCondLst>
                              <p:cond delay="0"/>
                            </p:stCondLst>
                            <p:childTnLst>
                              <p:par>
                                <p:cTn id="4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9" fill="hold">
                      <p:stCondLst>
                        <p:cond delay="indefinite"/>
                      </p:stCondLst>
                      <p:childTnLst>
                        <p:par>
                          <p:cTn id="50" fill="hold">
                            <p:stCondLst>
                              <p:cond delay="0"/>
                            </p:stCondLst>
                            <p:childTnLst>
                              <p:par>
                                <p:cTn id="5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7" fill="hold">
                      <p:stCondLst>
                        <p:cond delay="indefinite"/>
                      </p:stCondLst>
                      <p:childTnLst>
                        <p:par>
                          <p:cTn id="58" fill="hold">
                            <p:stCondLst>
                              <p:cond delay="0"/>
                            </p:stCondLst>
                            <p:childTnLst>
                              <p:par>
                                <p:cTn id="5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5" fill="hold">
                      <p:stCondLst>
                        <p:cond delay="indefinite"/>
                      </p:stCondLst>
                      <p:childTnLst>
                        <p:par>
                          <p:cTn id="66" fill="hold">
                            <p:stCondLst>
                              <p:cond delay="0"/>
                            </p:stCondLst>
                            <p:childTnLst>
                              <p:par>
                                <p:cTn id="6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1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7" fill="hold">
                      <p:stCondLst>
                        <p:cond delay="indefinite"/>
                      </p:stCondLst>
                      <p:childTnLst>
                        <p:par>
                          <p:cTn id="88" fill="hold">
                            <p:stCondLst>
                              <p:cond delay="0"/>
                            </p:stCondLst>
                            <p:childTnLst>
                              <p:par>
                                <p:cTn id="8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5" fill="hold">
                      <p:stCondLst>
                        <p:cond delay="indefinite"/>
                      </p:stCondLst>
                      <p:childTnLst>
                        <p:par>
                          <p:cTn id="96" fill="hold">
                            <p:stCondLst>
                              <p:cond delay="0"/>
                            </p:stCondLst>
                            <p:childTnLst>
                              <p:par>
                                <p:cTn id="9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9" grpId="0" animBg="1"/>
      <p:bldP spid="14" grpId="0" animBg="1"/>
      <p:bldP spid="15" grpId="0" animBg="1"/>
      <p:bldP spid="18" grpId="0"/>
      <p:bldP spid="19" grpId="0"/>
      <p:bldP spid="20" grpId="0"/>
      <p:bldP spid="21" grpId="0"/>
      <p:bldP spid="22" grpId="0"/>
      <p:bldP spid="23" grpId="0"/>
      <p:bldP spid="31" grpId="0"/>
      <p:bldP spid="32" grpId="0"/>
      <p:bldP spid="33" grpId="0" animBg="1"/>
      <p:bldP spid="37" grpId="0"/>
      <p:bldP spid="38" grpId="0"/>
      <p:bldP spid="40" grpId="0"/>
      <p:bldP spid="41" grpId="0"/>
      <p:bldP spid="42" grpId="0"/>
      <p:bldP spid="43" grpId="0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yed Vahid Mirnezami</dc:creator>
  <cp:lastModifiedBy>Seyed Vahid Mirnezami</cp:lastModifiedBy>
  <cp:revision>1</cp:revision>
  <dcterms:created xsi:type="dcterms:W3CDTF">2020-08-02T19:18:02Z</dcterms:created>
  <dcterms:modified xsi:type="dcterms:W3CDTF">2020-08-02T19:18:57Z</dcterms:modified>
</cp:coreProperties>
</file>